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2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73"/>
  </p:normalViewPr>
  <p:slideViewPr>
    <p:cSldViewPr snapToGrid="0" snapToObjects="1">
      <p:cViewPr varScale="1">
        <p:scale>
          <a:sx n="120" d="100"/>
          <a:sy n="120" d="100"/>
        </p:scale>
        <p:origin x="2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44434-B84F-AD4B-AB17-1CB89603BB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9FD258-35AA-0848-BEB6-F7E2048423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A7F3C0-AF50-354D-ABEB-01015ADF3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D94729-A637-C040-81B4-27733ACB1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5C57B-1179-8846-8EB1-1CA3B709B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72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1F2A55-A0AB-DB42-810B-F7DA9F340F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A69D1A-B6A6-A84B-BE83-34498F0F2F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1A2373-A81A-E841-8ACE-0E8BCA2895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F0F19C-BB27-5446-8786-006A2073A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9CECAC-9F40-E844-BE8A-CBE649E5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4831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F5E6BF-78F0-BA4D-AAAD-488D6DAF1D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3573F5-7673-F348-9BFB-7A96307D41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D0640-1232-A643-BF02-B6EA6DDB7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4E79D5-95B0-1A48-93A6-ABA1A4916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B2B4E-5277-3F4E-A932-10ADB368A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371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30B2E-8BF9-CF47-A65A-D91897002B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52CA5-DA98-C94A-9BA8-B6E28DA10D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734130-0938-4C4D-8F5A-DE8B07802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8F487-4ECC-FE47-B4AC-337FEB111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5DC81-C912-9346-BAEA-228611C6F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55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E182EB-07C7-DF4C-960B-858F96AE1D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D41825-4B5C-9249-A8EB-8C97BF9004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978D93-E9FA-5A49-877B-88B93241D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8B5F32-AEDF-3B4C-A426-63CBE8CF9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4070A-CEB6-2D43-B1F2-A86799BD9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629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762E7A-9530-AC46-9A3A-9B23C80F53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DBC879-8CF6-0645-97D7-9A2C9C338F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A2FCB3-A639-9C44-BEAC-530BC5C642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CCB611-8436-DB41-9E95-49E5D2A2C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61E82F-19AF-C449-8A16-8FD53CE1D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3A65D1-635D-DA42-B135-5CD210D6B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843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EFD246-59C3-4143-8C3B-4AE20523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647239-58D0-9041-A5FF-D09884B76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3D501C8-526A-0340-95DF-AA0237FFBE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AB9E16-7181-874B-8F60-EF03C86BB5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B72451-6840-FF43-8616-BF058D13A4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B4DC77-E525-294A-BFCC-59FA7612A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098E6C-8CF9-F34E-97C2-A06E491AF4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CAB4BB-192A-A642-B239-4A25D79B7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086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B91F2-5850-B04E-B5A4-AE69B2A19C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FB665E-4F24-9548-AFEF-847A7A15F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3EF650-D55A-B740-A441-3A27DE058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C30C34-5C7D-3C40-9531-554288EC7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851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0DD545-DD6A-604E-8515-C1B792756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3FDF7F-F3A7-6943-868B-0281598AB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2DAD08-9754-E440-9ACF-18FACCCD0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07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89441-BE6F-CD49-8C4C-5E92329A05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881D57-BD1E-6F40-9748-6894AEF13A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25945E-3C83-5C41-A842-89347BEB50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01022D-7394-E44A-A22C-B10B4761A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ACF60C-2115-C048-94F1-57B547F7F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2A1FE-9536-C04B-8647-7442BC4D8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240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24050F-7AE2-0947-84E4-FE7E58E51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0947427-9C67-D44E-80F6-253F5D2B71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3CBB25-0CEE-ED4C-ADAB-FEDD821B5D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6BCFF2-9C05-1241-AF44-0FCBA2FC0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300C2F-88B4-D345-BF6A-E4D29581A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57C1CD-FDBC-5644-94B5-0F34948016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238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0A8444-DCE4-3A42-AEEF-FA9C42FD9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B02445-47E3-DF45-97BD-BD9CEE5C4F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E158B7-0CC7-F949-83EC-4C973EFF8F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7D581-11F1-6143-A411-9C48CABA13B4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1C1F5-62AB-6149-8C83-B0ABE643D3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50B32C-0240-394B-91F0-D433EA783D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DB651-4B84-C84A-AC78-968C80BAB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276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AA8F507-AE4A-1047-A645-0119CE4FD54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1720"/>
          <a:stretch/>
        </p:blipFill>
        <p:spPr>
          <a:xfrm rot="16388845">
            <a:off x="6360432" y="726281"/>
            <a:ext cx="5518547" cy="536846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8162621-FCCA-0849-BF75-950C791D2F6A}"/>
              </a:ext>
            </a:extLst>
          </p:cNvPr>
          <p:cNvSpPr/>
          <p:nvPr/>
        </p:nvSpPr>
        <p:spPr>
          <a:xfrm>
            <a:off x="6582888" y="1567543"/>
            <a:ext cx="1991096" cy="29094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29AA8E6-7071-A642-A431-C2F8E9444050}"/>
              </a:ext>
            </a:extLst>
          </p:cNvPr>
          <p:cNvSpPr txBox="1"/>
          <p:nvPr/>
        </p:nvSpPr>
        <p:spPr>
          <a:xfrm>
            <a:off x="498764" y="373187"/>
            <a:ext cx="14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E right panel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6F14252-A8B5-D944-855F-954D73327CC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9261" r="46540"/>
          <a:stretch/>
        </p:blipFill>
        <p:spPr>
          <a:xfrm>
            <a:off x="971088" y="1567543"/>
            <a:ext cx="3243834" cy="3454110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62238D2-EE61-9844-9DE7-23FB1E9C4D91}"/>
              </a:ext>
            </a:extLst>
          </p:cNvPr>
          <p:cNvCxnSpPr>
            <a:cxnSpLocks/>
          </p:cNvCxnSpPr>
          <p:nvPr/>
        </p:nvCxnSpPr>
        <p:spPr>
          <a:xfrm flipV="1">
            <a:off x="3984978" y="2551289"/>
            <a:ext cx="2597910" cy="790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26420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29AA8E6-7071-A642-A431-C2F8E9444050}"/>
              </a:ext>
            </a:extLst>
          </p:cNvPr>
          <p:cNvSpPr txBox="1"/>
          <p:nvPr/>
        </p:nvSpPr>
        <p:spPr>
          <a:xfrm>
            <a:off x="498764" y="373187"/>
            <a:ext cx="14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E right panel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6F14252-A8B5-D944-855F-954D73327CC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9261" r="46540"/>
          <a:stretch/>
        </p:blipFill>
        <p:spPr>
          <a:xfrm>
            <a:off x="971088" y="1567543"/>
            <a:ext cx="3243834" cy="345411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5BAF982-37C0-D34F-98E5-077455AA6BF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8329" b="51388"/>
          <a:stretch/>
        </p:blipFill>
        <p:spPr>
          <a:xfrm rot="21445343">
            <a:off x="6096000" y="929590"/>
            <a:ext cx="4635360" cy="386270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8162621-FCCA-0849-BF75-950C791D2F6A}"/>
              </a:ext>
            </a:extLst>
          </p:cNvPr>
          <p:cNvSpPr/>
          <p:nvPr/>
        </p:nvSpPr>
        <p:spPr>
          <a:xfrm>
            <a:off x="6751674" y="1658679"/>
            <a:ext cx="1435396" cy="195639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A62238D2-EE61-9844-9DE7-23FB1E9C4D91}"/>
              </a:ext>
            </a:extLst>
          </p:cNvPr>
          <p:cNvCxnSpPr>
            <a:cxnSpLocks/>
          </p:cNvCxnSpPr>
          <p:nvPr/>
        </p:nvCxnSpPr>
        <p:spPr>
          <a:xfrm flipV="1">
            <a:off x="3984978" y="2551289"/>
            <a:ext cx="2597910" cy="790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901555E-3AFE-8B41-A7FE-1387B7976015}"/>
              </a:ext>
            </a:extLst>
          </p:cNvPr>
          <p:cNvSpPr txBox="1"/>
          <p:nvPr/>
        </p:nvSpPr>
        <p:spPr>
          <a:xfrm>
            <a:off x="6092450" y="272239"/>
            <a:ext cx="5235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lot Exposure similar to that used in Fig 1E right panel</a:t>
            </a:r>
          </a:p>
        </p:txBody>
      </p:sp>
    </p:spTree>
    <p:extLst>
      <p:ext uri="{BB962C8B-B14F-4D97-AF65-F5344CB8AC3E}">
        <p14:creationId xmlns:p14="http://schemas.microsoft.com/office/powerpoint/2010/main" val="30562024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06A9523-77B1-144E-B1C5-7A3BD4A275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8266" y="716001"/>
            <a:ext cx="4400361" cy="616050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0151A9D-E44F-5448-A14D-B3ECAA9CE4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1720"/>
          <a:stretch/>
        </p:blipFill>
        <p:spPr>
          <a:xfrm rot="16388845">
            <a:off x="1522482" y="1548053"/>
            <a:ext cx="4170294" cy="40568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F749232-CB4C-744F-9016-7434BCBA17C2}"/>
              </a:ext>
            </a:extLst>
          </p:cNvPr>
          <p:cNvSpPr txBox="1"/>
          <p:nvPr/>
        </p:nvSpPr>
        <p:spPr>
          <a:xfrm>
            <a:off x="6453962" y="59579"/>
            <a:ext cx="46491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ultiple Exposures of the experiment depicted </a:t>
            </a:r>
          </a:p>
          <a:p>
            <a:r>
              <a:rPr lang="en-US" dirty="0"/>
              <a:t>in Fig 1E right panel</a:t>
            </a:r>
          </a:p>
        </p:txBody>
      </p:sp>
    </p:spTree>
    <p:extLst>
      <p:ext uri="{BB962C8B-B14F-4D97-AF65-F5344CB8AC3E}">
        <p14:creationId xmlns:p14="http://schemas.microsoft.com/office/powerpoint/2010/main" val="122785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4</TotalTime>
  <Words>28</Words>
  <Application>Microsoft Macintosh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Sanjeev Galande</cp:lastModifiedBy>
  <cp:revision>4</cp:revision>
  <dcterms:created xsi:type="dcterms:W3CDTF">2022-02-10T11:03:36Z</dcterms:created>
  <dcterms:modified xsi:type="dcterms:W3CDTF">2022-02-11T11:56:26Z</dcterms:modified>
</cp:coreProperties>
</file>